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67" r:id="rId3"/>
    <p:sldId id="269" r:id="rId4"/>
    <p:sldId id="268" r:id="rId5"/>
    <p:sldId id="270" r:id="rId6"/>
    <p:sldId id="271" r:id="rId7"/>
    <p:sldId id="274" r:id="rId8"/>
    <p:sldId id="272" r:id="rId9"/>
    <p:sldId id="273" r:id="rId10"/>
    <p:sldId id="275" r:id="rId11"/>
    <p:sldId id="277" r:id="rId12"/>
    <p:sldId id="278" r:id="rId13"/>
    <p:sldId id="279" r:id="rId14"/>
    <p:sldId id="265" r:id="rId1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ni Moran" initials="RM" lastIdx="1" clrIdx="0">
    <p:extLst>
      <p:ext uri="{19B8F6BF-5375-455C-9EA6-DF929625EA0E}">
        <p15:presenceInfo xmlns:p15="http://schemas.microsoft.com/office/powerpoint/2012/main" userId="S-1-5-21-472060616-1524659645-6498272-686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18" autoAdjust="0"/>
    <p:restoredTop sz="94660"/>
  </p:normalViewPr>
  <p:slideViewPr>
    <p:cSldViewPr snapToGrid="0">
      <p:cViewPr varScale="1">
        <p:scale>
          <a:sx n="83" d="100"/>
          <a:sy n="83" d="100"/>
        </p:scale>
        <p:origin x="72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001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082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775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983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2040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1239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542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707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343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846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424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AE704F-14A2-4E4F-BDA2-B4AA5F276851}" type="datetimeFigureOut">
              <a:rPr lang="en-GB" smtClean="0"/>
              <a:t>22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C986CB-3FEE-445F-AC9E-BEFA3B16AC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035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jpg"/><Relationship Id="rId4" Type="http://schemas.openxmlformats.org/officeDocument/2006/relationships/image" Target="../media/image8.jp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GB" sz="4000" dirty="0" smtClean="0"/>
              <a:t>Please call the experimenter</a:t>
            </a:r>
            <a:endParaRPr lang="en-GB" sz="4000" dirty="0"/>
          </a:p>
        </p:txBody>
      </p:sp>
    </p:spTree>
    <p:extLst>
      <p:ext uri="{BB962C8B-B14F-4D97-AF65-F5344CB8AC3E}">
        <p14:creationId xmlns:p14="http://schemas.microsoft.com/office/powerpoint/2010/main" val="587994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Take your time to think carefully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To help you make great decisions, there is no time pressure on the reward setting questions</a:t>
            </a:r>
          </a:p>
          <a:p>
            <a:r>
              <a:rPr lang="en-GB" dirty="0" smtClean="0"/>
              <a:t>Please take your time to think carefully about how to set the treasure chances, considering what will aid you in earning more treasures when the task continues</a:t>
            </a:r>
          </a:p>
          <a:p>
            <a:r>
              <a:rPr lang="en-GB" dirty="0"/>
              <a:t>You will not be able to affect the </a:t>
            </a:r>
            <a:r>
              <a:rPr lang="en-GB" dirty="0" smtClean="0"/>
              <a:t>treasure chances </a:t>
            </a:r>
            <a:r>
              <a:rPr lang="en-GB" dirty="0"/>
              <a:t>for animals so think carefully about how to set vegetable </a:t>
            </a:r>
            <a:r>
              <a:rPr lang="en-GB" dirty="0" smtClean="0"/>
              <a:t>reward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45682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You will be asked the same reward setting question many times during the task</a:t>
            </a:r>
          </a:p>
          <a:p>
            <a:r>
              <a:rPr lang="en-GB" dirty="0" smtClean="0"/>
              <a:t>It is not necessarily good to choose the same setting again and again; You may do better if you consider each time which setting you </a:t>
            </a:r>
            <a:r>
              <a:rPr lang="en-GB" b="1" dirty="0" smtClean="0"/>
              <a:t>currently</a:t>
            </a:r>
            <a:r>
              <a:rPr lang="en-GB" dirty="0" smtClean="0"/>
              <a:t> find better!</a:t>
            </a:r>
          </a:p>
          <a:p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422" y="4718978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716" y="4718978"/>
            <a:ext cx="804861" cy="8048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80723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927017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680723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921881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835878" y="4001294"/>
            <a:ext cx="4578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oose Reward Setting (Up or Down)</a:t>
            </a:r>
          </a:p>
        </p:txBody>
      </p:sp>
    </p:spTree>
    <p:extLst>
      <p:ext uri="{BB962C8B-B14F-4D97-AF65-F5344CB8AC3E}">
        <p14:creationId xmlns:p14="http://schemas.microsoft.com/office/powerpoint/2010/main" val="3907198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For example, you may sometimes find it better to set         = 75%;        = 25% and at other times, the other way around:       = 25%;        = 75%</a:t>
            </a:r>
          </a:p>
          <a:p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422" y="4718978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716" y="4718978"/>
            <a:ext cx="804861" cy="8048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80723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927017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680723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921881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835878" y="4001294"/>
            <a:ext cx="4578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oose Reward Setting (Up or Down)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6464" y="2197014"/>
            <a:ext cx="436297" cy="436297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5048" y="2197014"/>
            <a:ext cx="436297" cy="43629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0723" y="2633312"/>
            <a:ext cx="436297" cy="436297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39630" y="2633311"/>
            <a:ext cx="436297" cy="436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41919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4327" y="3714402"/>
            <a:ext cx="3995030" cy="2996272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5103" y="886238"/>
            <a:ext cx="7886700" cy="4351338"/>
          </a:xfrm>
        </p:spPr>
        <p:txBody>
          <a:bodyPr/>
          <a:lstStyle/>
          <a:p>
            <a:r>
              <a:rPr lang="en-GB" dirty="0" smtClean="0"/>
              <a:t>After the treasure chances are set according to your choice they will start to change gradually once more…</a:t>
            </a:r>
          </a:p>
          <a:p>
            <a:r>
              <a:rPr lang="en-GB" dirty="0" smtClean="0"/>
              <a:t>Consider the arrows in the figure: The player chose to set       = 75%          = 25% (can you see this??); After that the treasure chances continue to gradually change from that point</a:t>
            </a:r>
            <a:endParaRPr lang="en-GB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1902516" y="4292720"/>
            <a:ext cx="419947" cy="19642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1897375" y="5805015"/>
            <a:ext cx="676318" cy="3057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304" y="2583094"/>
            <a:ext cx="436297" cy="436297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8888" y="2583094"/>
            <a:ext cx="436297" cy="43629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6947" y="4042224"/>
            <a:ext cx="436297" cy="43629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5718" y="5892603"/>
            <a:ext cx="436297" cy="436297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3112015" y="5957883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=25%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2853244" y="4075706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=75%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383853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Questions? Comments?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IS EVERYTHING CLEAR??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PLEASE DO NOT HESITATE TO ASK THE EXPERIMENTER!!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  <a:p>
            <a:pPr>
              <a:buFont typeface="Arial" panose="020B0604020202020204" pitchFamily="34" charset="0"/>
              <a:buChar char="•"/>
            </a:pPr>
            <a:r>
              <a:rPr lang="en-GB" dirty="0"/>
              <a:t>LET’S BEGIN!</a:t>
            </a:r>
          </a:p>
          <a:p>
            <a:pPr>
              <a:buFont typeface="Arial" panose="020B0604020202020204" pitchFamily="34" charset="0"/>
              <a:buChar char="•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69250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Putting the Control in your hands!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Great! Now that you have gained some expertise with the task, we will tell you more about it</a:t>
            </a:r>
          </a:p>
          <a:p>
            <a:r>
              <a:rPr lang="en-GB" dirty="0"/>
              <a:t>W</a:t>
            </a:r>
            <a:r>
              <a:rPr lang="en-GB" dirty="0" smtClean="0"/>
              <a:t>e really want to help you maximise your earning</a:t>
            </a:r>
          </a:p>
          <a:p>
            <a:r>
              <a:rPr lang="en-GB" dirty="0" smtClean="0"/>
              <a:t>So we are going to allow you to influence the rewards that the different vegetables provide</a:t>
            </a:r>
          </a:p>
          <a:p>
            <a:r>
              <a:rPr lang="en-GB" dirty="0" smtClean="0"/>
              <a:t>You will determine which of the vegetables will provide treasures with higher or lower chances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15860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Once in a few trials you will be asked a </a:t>
            </a:r>
            <a:r>
              <a:rPr lang="en-GB" b="1" dirty="0" smtClean="0"/>
              <a:t>Reward Setting</a:t>
            </a:r>
            <a:r>
              <a:rPr lang="en-GB" dirty="0" smtClean="0"/>
              <a:t> question that will look something like:</a:t>
            </a:r>
          </a:p>
          <a:p>
            <a:r>
              <a:rPr lang="en-GB" dirty="0" smtClean="0"/>
              <a:t>Do you want carrot to provide a treasure with 75% chances and tomato, with 25% (choose UP) or vice versa (Choose Down: Carrot = 25%; Tomato= 75%)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422" y="4718978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716" y="4718978"/>
            <a:ext cx="804861" cy="8048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680723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4927017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680723" y="5560658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4921881" y="434964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2835878" y="4001294"/>
            <a:ext cx="4578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oose Reward Setting (Up or Down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510102" y="4534312"/>
            <a:ext cx="10673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2479040" y="5745324"/>
            <a:ext cx="10673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947116" y="4349646"/>
            <a:ext cx="5319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UP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1774613" y="5560658"/>
            <a:ext cx="762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Down</a:t>
            </a:r>
            <a:endParaRPr lang="en-GB" dirty="0"/>
          </a:p>
        </p:txBody>
      </p:sp>
      <p:sp>
        <p:nvSpPr>
          <p:cNvPr id="2" name="Rectangle 1"/>
          <p:cNvSpPr/>
          <p:nvPr/>
        </p:nvSpPr>
        <p:spPr>
          <a:xfrm>
            <a:off x="3680723" y="4349646"/>
            <a:ext cx="1835657" cy="33251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/>
          <p:cNvSpPr/>
          <p:nvPr/>
        </p:nvSpPr>
        <p:spPr>
          <a:xfrm>
            <a:off x="3704247" y="5597921"/>
            <a:ext cx="1835657" cy="33251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5508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GB" dirty="0" smtClean="0"/>
          </a:p>
          <a:p>
            <a:r>
              <a:rPr lang="en-GB" dirty="0" smtClean="0"/>
              <a:t>            are used just for illustration. In the task you will be asked about the favourable vegetables       </a:t>
            </a:r>
          </a:p>
          <a:p>
            <a:r>
              <a:rPr lang="en-GB" dirty="0" smtClean="0"/>
              <a:t>If you select up          we will set the chances that       provides a reward to 75% and the chances that      provide a reward to 25%</a:t>
            </a:r>
          </a:p>
          <a:p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422" y="5121004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716" y="5121004"/>
            <a:ext cx="804861" cy="80486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927017" y="596268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680723" y="596268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7" name="Rectangle 16"/>
          <p:cNvSpPr/>
          <p:nvPr/>
        </p:nvSpPr>
        <p:spPr>
          <a:xfrm>
            <a:off x="3608547" y="4696667"/>
            <a:ext cx="1918494" cy="3547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75%                25%</a:t>
            </a:r>
            <a:endParaRPr lang="en-GB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0699" y="3197592"/>
            <a:ext cx="551445" cy="55144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7943" y="3315882"/>
            <a:ext cx="314864" cy="31486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4423" y="3654086"/>
            <a:ext cx="314864" cy="314864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3577" y="2422761"/>
            <a:ext cx="314864" cy="314864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850" y="2422761"/>
            <a:ext cx="314864" cy="314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3590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If you select down       we will set the chances that       provides a reward to 25% and the chances that      provide a reward to 75%</a:t>
            </a:r>
          </a:p>
          <a:p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6422" y="4718978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716" y="4718978"/>
            <a:ext cx="804861" cy="80486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680723" y="429258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27017" y="4292586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6" name="Rectangle 15"/>
          <p:cNvSpPr/>
          <p:nvPr/>
        </p:nvSpPr>
        <p:spPr>
          <a:xfrm>
            <a:off x="2394484" y="3443492"/>
            <a:ext cx="4250156" cy="47595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/>
          <p:cNvSpPr/>
          <p:nvPr/>
        </p:nvSpPr>
        <p:spPr>
          <a:xfrm>
            <a:off x="3611932" y="5673037"/>
            <a:ext cx="1918494" cy="35472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25%               75%</a:t>
            </a:r>
            <a:endParaRPr lang="en-GB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4377" y="1928119"/>
            <a:ext cx="314864" cy="314864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4423" y="2258779"/>
            <a:ext cx="314864" cy="314864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1932" y="1786920"/>
            <a:ext cx="519853" cy="519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8257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So your choice influences which vegetables will provide treasures with lower and higher chances!</a:t>
            </a:r>
          </a:p>
          <a:p>
            <a:r>
              <a:rPr lang="en-GB" dirty="0" smtClean="0"/>
              <a:t>Imagine how rich you’d be if you were able to control prices of stocks </a:t>
            </a:r>
            <a:r>
              <a:rPr lang="en-GB" dirty="0" smtClean="0">
                <a:sym typeface="Wingdings" panose="05000000000000000000" pitchFamily="2" charset="2"/>
              </a:rPr>
              <a:t></a:t>
            </a:r>
            <a:endParaRPr lang="en-GB" dirty="0" smtClean="0"/>
          </a:p>
          <a:p>
            <a:r>
              <a:rPr lang="en-GB" dirty="0" smtClean="0"/>
              <a:t>Well, here you can control the chances that vegetables will provide treasur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02804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Please pay careful attention to the question framing because it may appear in two ways</a:t>
            </a:r>
          </a:p>
          <a:p>
            <a:r>
              <a:rPr lang="en-GB" dirty="0" smtClean="0"/>
              <a:t>Note that choosing up for the question on the left will have the same effect as choosing down for the question on the right (       = 75%;        = 25%) and vice versa; So examine the question carefully!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980" y="5260844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1274" y="5260844"/>
            <a:ext cx="804861" cy="804861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29281" y="4875273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2875575" y="610252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1629281" y="610252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2870439" y="4891512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4436" y="4543160"/>
            <a:ext cx="4578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oose Reward Setting (Up or Down)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8119" y="5260844"/>
            <a:ext cx="804861" cy="804861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4413" y="5260844"/>
            <a:ext cx="804861" cy="804861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782420" y="4891512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7028714" y="610252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%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5782420" y="6102524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7023578" y="4891512"/>
            <a:ext cx="670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%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4937575" y="4543160"/>
            <a:ext cx="4578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hoose Reward Setting (Up or Down)</a:t>
            </a: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6240" y="3507156"/>
            <a:ext cx="436297" cy="436297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2420" y="3507156"/>
            <a:ext cx="436297" cy="436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28097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41824" y="1812078"/>
            <a:ext cx="7886700" cy="4351338"/>
          </a:xfrm>
        </p:spPr>
        <p:txBody>
          <a:bodyPr/>
          <a:lstStyle/>
          <a:p>
            <a:r>
              <a:rPr lang="en-GB" dirty="0" smtClean="0"/>
              <a:t>Remember that different people  have different favourable vegetables…</a:t>
            </a:r>
          </a:p>
          <a:p>
            <a:r>
              <a:rPr lang="en-GB" dirty="0" smtClean="0"/>
              <a:t>So when you determine which vegetable are more likely to provide a treasure you affect the chances to get a treasure by choosing the different people-pictures!</a:t>
            </a:r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1724" y="4698658"/>
            <a:ext cx="804861" cy="80486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5737" y="4698657"/>
            <a:ext cx="804861" cy="80486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1724" y="5648774"/>
            <a:ext cx="804861" cy="80486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5737" y="5648774"/>
            <a:ext cx="804861" cy="804861"/>
          </a:xfrm>
          <a:prstGeom prst="rect">
            <a:avLst/>
          </a:prstGeom>
        </p:spPr>
      </p:pic>
      <p:cxnSp>
        <p:nvCxnSpPr>
          <p:cNvPr id="8" name="Straight Arrow Connector 7"/>
          <p:cNvCxnSpPr/>
          <p:nvPr/>
        </p:nvCxnSpPr>
        <p:spPr>
          <a:xfrm>
            <a:off x="4506358" y="5101087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>
            <a:off x="4506358" y="6024500"/>
            <a:ext cx="59531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07306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 smtClean="0"/>
              <a:t>You will actually be asked 2 reward setting questions one after another</a:t>
            </a:r>
          </a:p>
          <a:p>
            <a:r>
              <a:rPr lang="en-GB" dirty="0" smtClean="0"/>
              <a:t>The 1</a:t>
            </a:r>
            <a:r>
              <a:rPr lang="en-GB" baseline="30000" dirty="0" smtClean="0"/>
              <a:t>st</a:t>
            </a:r>
            <a:r>
              <a:rPr lang="en-GB" dirty="0" smtClean="0"/>
              <a:t> question will feature one pair of the 4 vegetable</a:t>
            </a:r>
          </a:p>
          <a:p>
            <a:r>
              <a:rPr lang="en-GB" dirty="0" smtClean="0"/>
              <a:t>The 2</a:t>
            </a:r>
            <a:r>
              <a:rPr lang="en-GB" baseline="30000" dirty="0" smtClean="0"/>
              <a:t>nd</a:t>
            </a:r>
            <a:r>
              <a:rPr lang="en-GB" dirty="0" smtClean="0"/>
              <a:t> question will feature the other pair of vegetabl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82354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19</TotalTime>
  <Words>693</Words>
  <Application>Microsoft Office PowerPoint</Application>
  <PresentationFormat>On-screen Show (4:3)</PresentationFormat>
  <Paragraphs>72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Wingdings</vt:lpstr>
      <vt:lpstr>Office Theme</vt:lpstr>
      <vt:lpstr>PowerPoint Presentation</vt:lpstr>
      <vt:lpstr>Putting the Control in your hands!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ke your time to think carefully</vt:lpstr>
      <vt:lpstr>PowerPoint Presentation</vt:lpstr>
      <vt:lpstr>PowerPoint Presentation</vt:lpstr>
      <vt:lpstr>PowerPoint Presentation</vt:lpstr>
      <vt:lpstr>Questions? Comments?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Castle Ghost</dc:title>
  <dc:creator>Rani Moran</dc:creator>
  <cp:lastModifiedBy>Rani Moran</cp:lastModifiedBy>
  <cp:revision>47</cp:revision>
  <dcterms:created xsi:type="dcterms:W3CDTF">2017-06-20T15:04:54Z</dcterms:created>
  <dcterms:modified xsi:type="dcterms:W3CDTF">2017-11-27T17:28:48Z</dcterms:modified>
</cp:coreProperties>
</file>